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723" r:id="rId2"/>
  </p:sldIdLst>
  <p:sldSz cx="7315200" cy="9321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54CFF"/>
    <a:srgbClr val="00B5FF"/>
    <a:srgbClr val="A20305"/>
    <a:srgbClr val="A3030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2857"/>
    <p:restoredTop sz="95564"/>
  </p:normalViewPr>
  <p:slideViewPr>
    <p:cSldViewPr snapToGrid="0" snapToObjects="1">
      <p:cViewPr varScale="1">
        <p:scale>
          <a:sx n="80" d="100"/>
          <a:sy n="80" d="100"/>
        </p:scale>
        <p:origin x="2600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F5A565-0660-F24A-9241-43E2B99AF08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1143000"/>
            <a:ext cx="2422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1F7975-6509-8042-909C-D5380521D3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7109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525583"/>
            <a:ext cx="6217920" cy="3245367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4896103"/>
            <a:ext cx="5486400" cy="2250610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2741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232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496299"/>
            <a:ext cx="1577340" cy="789979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496299"/>
            <a:ext cx="4640580" cy="789979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7221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493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323979"/>
            <a:ext cx="6309360" cy="3877609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238272"/>
            <a:ext cx="6309360" cy="2039143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228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481498"/>
            <a:ext cx="3108960" cy="59145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481498"/>
            <a:ext cx="3108960" cy="591459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569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496301"/>
            <a:ext cx="6309360" cy="18017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285136"/>
            <a:ext cx="3094672" cy="1119910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405047"/>
            <a:ext cx="3094672" cy="500831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285136"/>
            <a:ext cx="3109913" cy="1119910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405047"/>
            <a:ext cx="3109913" cy="500831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471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593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97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21453"/>
            <a:ext cx="2359342" cy="2175087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342169"/>
            <a:ext cx="3703320" cy="6624520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96540"/>
            <a:ext cx="2359342" cy="5180936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67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21453"/>
            <a:ext cx="2359342" cy="2175087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342169"/>
            <a:ext cx="3703320" cy="6624520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96540"/>
            <a:ext cx="2359342" cy="5180936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378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496301"/>
            <a:ext cx="6309360" cy="18017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481498"/>
            <a:ext cx="6309360" cy="591459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8639929"/>
            <a:ext cx="164592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148797-AA0A-B942-B8DF-591680252009}" type="datetimeFigureOut">
              <a:rPr lang="en-US" smtClean="0"/>
              <a:t>5/10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8639929"/>
            <a:ext cx="246888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8639929"/>
            <a:ext cx="1645920" cy="49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F7C043-39E4-F644-B629-FD630E6F8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5951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extBox 71">
            <a:extLst>
              <a:ext uri="{FF2B5EF4-FFF2-40B4-BE49-F238E27FC236}">
                <a16:creationId xmlns:a16="http://schemas.microsoft.com/office/drawing/2014/main" id="{375F14D8-2334-0643-B009-3E33C8D18FA6}"/>
              </a:ext>
            </a:extLst>
          </p:cNvPr>
          <p:cNvSpPr txBox="1"/>
          <p:nvPr/>
        </p:nvSpPr>
        <p:spPr>
          <a:xfrm>
            <a:off x="2792758" y="3273224"/>
            <a:ext cx="3577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E.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901E4EF5-E025-E447-9776-2A4665045A6F}"/>
              </a:ext>
            </a:extLst>
          </p:cNvPr>
          <p:cNvSpPr txBox="1"/>
          <p:nvPr/>
        </p:nvSpPr>
        <p:spPr>
          <a:xfrm>
            <a:off x="-5703" y="315283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E387C340-1739-FC49-902F-539B21FBB307}"/>
              </a:ext>
            </a:extLst>
          </p:cNvPr>
          <p:cNvSpPr txBox="1"/>
          <p:nvPr/>
        </p:nvSpPr>
        <p:spPr>
          <a:xfrm>
            <a:off x="2219768" y="281983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2E6D2ECE-00C4-7740-9E14-FEE6EFD5651C}"/>
              </a:ext>
            </a:extLst>
          </p:cNvPr>
          <p:cNvSpPr txBox="1"/>
          <p:nvPr/>
        </p:nvSpPr>
        <p:spPr>
          <a:xfrm>
            <a:off x="4544206" y="235906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.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6766B328-888A-764A-998B-AF72E8D67632}"/>
              </a:ext>
            </a:extLst>
          </p:cNvPr>
          <p:cNvSpPr txBox="1"/>
          <p:nvPr/>
        </p:nvSpPr>
        <p:spPr>
          <a:xfrm>
            <a:off x="-5703" y="3301790"/>
            <a:ext cx="3863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.</a:t>
            </a: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4C1565B2-F541-0149-A287-338FB03829C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4658" r="41066"/>
          <a:stretch/>
        </p:blipFill>
        <p:spPr>
          <a:xfrm>
            <a:off x="163499" y="508528"/>
            <a:ext cx="2014445" cy="1684361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D316C152-56B9-044B-A3DD-B1049F7BAB6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0372" t="24658" r="677" b="26738"/>
          <a:stretch/>
        </p:blipFill>
        <p:spPr>
          <a:xfrm>
            <a:off x="502584" y="2066653"/>
            <a:ext cx="1571697" cy="1282728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A7E00142-C8DA-2541-8F1C-22BF998ADEC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25880" r="45010"/>
          <a:stretch/>
        </p:blipFill>
        <p:spPr>
          <a:xfrm>
            <a:off x="2439329" y="484437"/>
            <a:ext cx="1948451" cy="1685860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EF56D7B0-B21A-3A44-86A7-4B7173E2E09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9648" t="25881" r="-1174" b="32155"/>
          <a:stretch/>
        </p:blipFill>
        <p:spPr>
          <a:xfrm>
            <a:off x="2792758" y="2082854"/>
            <a:ext cx="1742353" cy="1130258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199AD930-E562-6D43-BCFF-7B24AA263FA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t="22396" r="44690"/>
          <a:stretch/>
        </p:blipFill>
        <p:spPr>
          <a:xfrm>
            <a:off x="4805592" y="412102"/>
            <a:ext cx="1967715" cy="1758195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1DE1967F-B8E5-C247-A952-B85716FC08F6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6903" t="27219" r="-1717" b="26908"/>
          <a:stretch/>
        </p:blipFill>
        <p:spPr>
          <a:xfrm>
            <a:off x="5125423" y="2104753"/>
            <a:ext cx="1909269" cy="1244628"/>
          </a:xfrm>
          <a:prstGeom prst="rect">
            <a:avLst/>
          </a:prstGeom>
        </p:spPr>
      </p:pic>
      <p:sp>
        <p:nvSpPr>
          <p:cNvPr id="18" name="Title 1">
            <a:extLst>
              <a:ext uri="{FF2B5EF4-FFF2-40B4-BE49-F238E27FC236}">
                <a16:creationId xmlns:a16="http://schemas.microsoft.com/office/drawing/2014/main" id="{B025A8C5-4063-7640-BB08-96CA837E97F8}"/>
              </a:ext>
            </a:extLst>
          </p:cNvPr>
          <p:cNvSpPr txBox="1">
            <a:spLocks/>
          </p:cNvSpPr>
          <p:nvPr/>
        </p:nvSpPr>
        <p:spPr>
          <a:xfrm>
            <a:off x="0" y="49937"/>
            <a:ext cx="3150548" cy="355140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5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0D33B36-3F99-A140-9764-B75D545683B7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8854" r="46325" b="54930"/>
          <a:stretch/>
        </p:blipFill>
        <p:spPr>
          <a:xfrm>
            <a:off x="90696" y="3463458"/>
            <a:ext cx="2501563" cy="1684361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0398A665-034E-B74D-873B-3371883363A6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52992" t="8854" r="343" b="54930"/>
          <a:stretch/>
        </p:blipFill>
        <p:spPr>
          <a:xfrm>
            <a:off x="502584" y="5063224"/>
            <a:ext cx="2174827" cy="168436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220D946-77D7-8B4E-A554-E45D48F007EE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23491" r="48934" b="29103"/>
          <a:stretch/>
        </p:blipFill>
        <p:spPr>
          <a:xfrm>
            <a:off x="2882247" y="3391848"/>
            <a:ext cx="2151067" cy="178012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802BDB1E-3E1E-C744-89D3-74BB77A9DF1E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52701" t="28921" r="-1009" b="37934"/>
          <a:stretch/>
        </p:blipFill>
        <p:spPr>
          <a:xfrm>
            <a:off x="3370349" y="5206043"/>
            <a:ext cx="2034862" cy="1244628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07D61BC3-CCAA-C24C-935C-FFB4111E5647}"/>
              </a:ext>
            </a:extLst>
          </p:cNvPr>
          <p:cNvSpPr txBox="1"/>
          <p:nvPr/>
        </p:nvSpPr>
        <p:spPr>
          <a:xfrm>
            <a:off x="0" y="6735932"/>
            <a:ext cx="7320903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i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Supplementary Figure S3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: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Targeting CD73 sensitizes quasi-mesenchymal tumors to anti-CTLA4 immune checkpoint blockade therapy in a CD4</a:t>
            </a:r>
            <a:r>
              <a:rPr lang="en-US" sz="1200" b="1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+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-cell dependent manner 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A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umor weights for sgCD73 tumor-bearing mice treated with the indicated antibodies. Data represent three independent experiments where n=3-4 for each group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umor weights for sgCD73 tumors propagated in Wild Type (WT) or CD4 knock-out (CD4-KO) mice treated with the indicated antibodies. Data represent four independent experiments where n=2-4 for each group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C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umor weights for sgCD73 tumors propagated in Wild Type (WT) or MHC-II knock-out (MHC-II-KO) mice treated with the indicated antibodies. Data represent three independent experiments where n=3-7 for each group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D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umor weights for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Snail</a:t>
            </a:r>
            <a:r>
              <a:rPr lang="en-US" sz="1200" baseline="300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HI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qM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umor-bearing mice treated with the indicated antibodies. R represents responders and NR represents non-responders. Data represent three independent experiments where n=3-4 for each group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E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Tumor weights for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Snail</a:t>
            </a:r>
            <a:r>
              <a:rPr lang="en-US" sz="1200" baseline="300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HI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</a:t>
            </a:r>
            <a:r>
              <a:rPr lang="en-US" sz="1200" dirty="0" err="1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qM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 tumors propagated in Wild Type (WT) or CD4 knock-out (CD4-KO) mice treated with the indicated antibodies. R represents responders and NR represents non-responders. Data represent three independent experiments where n=2-4 for each group. (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A-E</a:t>
            </a:r>
            <a:r>
              <a:rPr lang="en-US" sz="1200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) Bar graph data represent SEM, two-tailed unpaired t-test, **, p&lt;0.01, ***, p&lt;0.001, ns=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" pitchFamily="2" charset="0"/>
                <a:ea typeface="Times" pitchFamily="2" charset="0"/>
                <a:cs typeface="Times" pitchFamily="2" charset="0"/>
              </a:rPr>
              <a:t>non-significant.</a:t>
            </a:r>
            <a:endParaRPr lang="en-US" sz="1200" dirty="0">
              <a:effectLst/>
              <a:latin typeface="Times" pitchFamily="2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US" sz="1200" dirty="0">
              <a:latin typeface="Times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661460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22</TotalTime>
  <Words>258</Words>
  <Application>Microsoft Macintosh PowerPoint</Application>
  <PresentationFormat>Custom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ject #2</dc:title>
  <dc:creator>Microsoft Office User</dc:creator>
  <cp:lastModifiedBy>Anushka Dongre</cp:lastModifiedBy>
  <cp:revision>418</cp:revision>
  <dcterms:created xsi:type="dcterms:W3CDTF">2023-02-11T23:37:55Z</dcterms:created>
  <dcterms:modified xsi:type="dcterms:W3CDTF">2026-05-11T01:27:26Z</dcterms:modified>
</cp:coreProperties>
</file>